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9" r:id="rId2"/>
    <p:sldId id="260" r:id="rId3"/>
    <p:sldId id="261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>
        <p:guide orient="horz" pos="218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4ACF2-CD87-8445-BD76-55BFE8A4421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F705E-C722-8C46-94BC-8A864F2EE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197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51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77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34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40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42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593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282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91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74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8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776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384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0F658C4-6BE9-2B41-A7DB-183DAA5886E9}"/>
              </a:ext>
            </a:extLst>
          </p:cNvPr>
          <p:cNvSpPr txBox="1"/>
          <p:nvPr/>
        </p:nvSpPr>
        <p:spPr>
          <a:xfrm>
            <a:off x="-1" y="-28805"/>
            <a:ext cx="23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1 (contd.)</a:t>
            </a:r>
            <a:endParaRPr kumimoji="1" lang="ja-JP" altLang="en-US" sz="1200">
              <a:latin typeface="Helvetica" pitchFamily="2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0B17FB10-3B5F-7E48-85DD-9DA7F3FE3987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515679" cy="6146519"/>
            <a:chOff x="-36000" y="0"/>
            <a:chExt cx="9376708" cy="6768000"/>
          </a:xfrm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0723366-0E2D-D348-BC8C-57480DD0B617}"/>
                </a:ext>
              </a:extLst>
            </p:cNvPr>
            <p:cNvSpPr txBox="1"/>
            <p:nvPr/>
          </p:nvSpPr>
          <p:spPr>
            <a:xfrm>
              <a:off x="-36000" y="0"/>
              <a:ext cx="31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2E42738-6F10-8C48-83AE-325EAF22D63A}"/>
                </a:ext>
              </a:extLst>
            </p:cNvPr>
            <p:cNvSpPr txBox="1"/>
            <p:nvPr/>
          </p:nvSpPr>
          <p:spPr>
            <a:xfrm>
              <a:off x="144000" y="8415"/>
              <a:ext cx="225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F72D5E6-FFC6-534E-8E5D-A99EE5983B55}"/>
                </a:ext>
              </a:extLst>
            </p:cNvPr>
            <p:cNvSpPr txBox="1"/>
            <p:nvPr/>
          </p:nvSpPr>
          <p:spPr>
            <a:xfrm>
              <a:off x="14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6–1.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9DA48C0-2DBE-7243-9D2F-4ABBFB82688D}"/>
                </a:ext>
              </a:extLst>
            </p:cNvPr>
            <p:cNvSpPr txBox="1"/>
            <p:nvPr/>
          </p:nvSpPr>
          <p:spPr>
            <a:xfrm>
              <a:off x="2320628" y="0"/>
              <a:ext cx="4340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A2758C1-F181-4140-801E-491E7C82BA13}"/>
                </a:ext>
              </a:extLst>
            </p:cNvPr>
            <p:cNvSpPr txBox="1"/>
            <p:nvPr/>
          </p:nvSpPr>
          <p:spPr>
            <a:xfrm>
              <a:off x="2500629" y="7200"/>
              <a:ext cx="2177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A9104CF2-503E-8343-A51D-940991160FC3}"/>
                </a:ext>
              </a:extLst>
            </p:cNvPr>
            <p:cNvSpPr txBox="1"/>
            <p:nvPr/>
          </p:nvSpPr>
          <p:spPr>
            <a:xfrm>
              <a:off x="2502000" y="180000"/>
              <a:ext cx="14830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6, 95% CI 1.03–2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E5ED6D4F-8A30-D643-8340-9FBFBBBC3023}"/>
                </a:ext>
              </a:extLst>
            </p:cNvPr>
            <p:cNvSpPr txBox="1"/>
            <p:nvPr/>
          </p:nvSpPr>
          <p:spPr>
            <a:xfrm>
              <a:off x="4571284" y="0"/>
              <a:ext cx="286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19F478E-046A-634F-B458-1DC200CC297B}"/>
                </a:ext>
              </a:extLst>
            </p:cNvPr>
            <p:cNvSpPr txBox="1"/>
            <p:nvPr/>
          </p:nvSpPr>
          <p:spPr>
            <a:xfrm>
              <a:off x="4752218" y="8415"/>
              <a:ext cx="1890758" cy="406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containing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F6FF4D0-8854-FD42-AF4A-BCF81AAB5EE0}"/>
                </a:ext>
              </a:extLst>
            </p:cNvPr>
            <p:cNvSpPr txBox="1"/>
            <p:nvPr/>
          </p:nvSpPr>
          <p:spPr>
            <a:xfrm>
              <a:off x="4752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7, 95% CI 1.6–1.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EAF20C2-C1E8-EC4D-A8C4-1BA35CF56796}"/>
                </a:ext>
              </a:extLst>
            </p:cNvPr>
            <p:cNvSpPr txBox="1"/>
            <p:nvPr/>
          </p:nvSpPr>
          <p:spPr>
            <a:xfrm>
              <a:off x="6912000" y="0"/>
              <a:ext cx="317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685B8C71-57DD-8B44-8506-9DE22F846657}"/>
                </a:ext>
              </a:extLst>
            </p:cNvPr>
            <p:cNvSpPr txBox="1"/>
            <p:nvPr/>
          </p:nvSpPr>
          <p:spPr>
            <a:xfrm>
              <a:off x="7093755" y="8415"/>
              <a:ext cx="22469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utyrophenone derivatives (N05AD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C6E7C7A-04F9-A645-9C31-366B44A8FC8F}"/>
                </a:ext>
              </a:extLst>
            </p:cNvPr>
            <p:cNvSpPr txBox="1"/>
            <p:nvPr/>
          </p:nvSpPr>
          <p:spPr>
            <a:xfrm>
              <a:off x="7092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7–1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BA28A413-1461-0E44-A942-5BB85CAAB182}"/>
                </a:ext>
              </a:extLst>
            </p:cNvPr>
            <p:cNvSpPr txBox="1"/>
            <p:nvPr/>
          </p:nvSpPr>
          <p:spPr>
            <a:xfrm>
              <a:off x="-36000" y="3492000"/>
              <a:ext cx="5671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49D38F93-9130-8944-8477-195E1A45831E}"/>
                </a:ext>
              </a:extLst>
            </p:cNvPr>
            <p:cNvSpPr txBox="1"/>
            <p:nvPr/>
          </p:nvSpPr>
          <p:spPr>
            <a:xfrm>
              <a:off x="144001" y="3499200"/>
              <a:ext cx="2035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Coxibs</a:t>
              </a:r>
              <a:r>
                <a:rPr lang="en-US" altLang="ja-JP" sz="900" dirty="0">
                  <a:latin typeface="Helvetica" pitchFamily="2" charset="0"/>
                </a:rPr>
                <a:t> (M01AH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ED1CBE4-1D08-4A4D-BCB0-40A854794E4E}"/>
                </a:ext>
              </a:extLst>
            </p:cNvPr>
            <p:cNvSpPr txBox="1"/>
            <p:nvPr/>
          </p:nvSpPr>
          <p:spPr>
            <a:xfrm>
              <a:off x="144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4, 95% CI 0.9–2.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10F321E8-910C-8746-8C8C-A848F6AB2267}"/>
                </a:ext>
              </a:extLst>
            </p:cNvPr>
            <p:cNvSpPr txBox="1"/>
            <p:nvPr/>
          </p:nvSpPr>
          <p:spPr>
            <a:xfrm>
              <a:off x="2322000" y="3492000"/>
              <a:ext cx="3150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DFAFA735-8167-AB47-AD7C-927C64413A7C}"/>
                </a:ext>
              </a:extLst>
            </p:cNvPr>
            <p:cNvSpPr txBox="1"/>
            <p:nvPr/>
          </p:nvSpPr>
          <p:spPr>
            <a:xfrm>
              <a:off x="2502001" y="3499200"/>
              <a:ext cx="211468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,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 and oxepines (N05AH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C6435398-046B-6344-B822-24439B486A09}"/>
                </a:ext>
              </a:extLst>
            </p:cNvPr>
            <p:cNvSpPr txBox="1"/>
            <p:nvPr/>
          </p:nvSpPr>
          <p:spPr>
            <a:xfrm>
              <a:off x="250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9–1.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D8107A19-B2C4-C94A-B34D-8A341E92AAF1}"/>
                </a:ext>
              </a:extLst>
            </p:cNvPr>
            <p:cNvSpPr txBox="1"/>
            <p:nvPr/>
          </p:nvSpPr>
          <p:spPr>
            <a:xfrm>
              <a:off x="4571999" y="3492000"/>
              <a:ext cx="3189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52AC332C-4527-8443-BDC4-1FF79DC5362D}"/>
                </a:ext>
              </a:extLst>
            </p:cNvPr>
            <p:cNvSpPr txBox="1"/>
            <p:nvPr/>
          </p:nvSpPr>
          <p:spPr>
            <a:xfrm>
              <a:off x="4752000" y="3499200"/>
              <a:ext cx="2248155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 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2F844E2-843B-D045-A565-397B1E70F962}"/>
                </a:ext>
              </a:extLst>
            </p:cNvPr>
            <p:cNvSpPr txBox="1"/>
            <p:nvPr/>
          </p:nvSpPr>
          <p:spPr>
            <a:xfrm>
              <a:off x="475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9–1.3)</a:t>
              </a: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8F61BC6-12EE-D242-BD94-FB937B1F130F}"/>
                </a:ext>
              </a:extLst>
            </p:cNvPr>
            <p:cNvSpPr txBox="1"/>
            <p:nvPr/>
          </p:nvSpPr>
          <p:spPr>
            <a:xfrm>
              <a:off x="6912000" y="3492000"/>
              <a:ext cx="3480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8D047454-E5E5-A149-A17D-FAE8280FFC5B}"/>
                </a:ext>
              </a:extLst>
            </p:cNvPr>
            <p:cNvSpPr txBox="1"/>
            <p:nvPr/>
          </p:nvSpPr>
          <p:spPr>
            <a:xfrm>
              <a:off x="7092000" y="3499200"/>
              <a:ext cx="2228153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and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continence (G04BD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7196DC4A-98C1-6E41-BE9E-1CC4C865347E}"/>
                </a:ext>
              </a:extLst>
            </p:cNvPr>
            <p:cNvSpPr txBox="1"/>
            <p:nvPr/>
          </p:nvSpPr>
          <p:spPr>
            <a:xfrm>
              <a:off x="709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8–1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364A4D7A-A07E-0B4F-A73D-8F00EB8B99DD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9B9818E8-6FF5-7848-8521-64B79793DDD4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5644824B-512D-024C-B735-A39D509D74D1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2C7A5DEB-53C0-B249-B2C2-B05FA243EC4C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F088825-3997-0241-A61C-4DD1EF7E28CB}"/>
                </a:ext>
              </a:extLst>
            </p:cNvPr>
            <p:cNvSpPr txBox="1"/>
            <p:nvPr/>
          </p:nvSpPr>
          <p:spPr>
            <a:xfrm>
              <a:off x="-360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067DF5A0-ED27-BC4A-A848-40C16F1718FE}"/>
                </a:ext>
              </a:extLst>
            </p:cNvPr>
            <p:cNvSpPr txBox="1"/>
            <p:nvPr/>
          </p:nvSpPr>
          <p:spPr>
            <a:xfrm>
              <a:off x="69732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F76AC956-B7BD-D54C-8F45-D0FBEC4209AC}"/>
                </a:ext>
              </a:extLst>
            </p:cNvPr>
            <p:cNvSpPr txBox="1"/>
            <p:nvPr/>
          </p:nvSpPr>
          <p:spPr>
            <a:xfrm>
              <a:off x="46368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F3A76B69-3A46-824B-8EA1-D0E4902AE150}"/>
                </a:ext>
              </a:extLst>
            </p:cNvPr>
            <p:cNvSpPr txBox="1"/>
            <p:nvPr/>
          </p:nvSpPr>
          <p:spPr>
            <a:xfrm>
              <a:off x="23004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39" name="図 38">
              <a:extLst>
                <a:ext uri="{FF2B5EF4-FFF2-40B4-BE49-F238E27FC236}">
                  <a16:creationId xmlns:a16="http://schemas.microsoft.com/office/drawing/2014/main" id="{75E4C704-DF33-B04E-9E35-EF6E3FD6B867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l="7707" b="8264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40" name="図 39">
              <a:extLst>
                <a:ext uri="{FF2B5EF4-FFF2-40B4-BE49-F238E27FC236}">
                  <a16:creationId xmlns:a16="http://schemas.microsoft.com/office/drawing/2014/main" id="{98A9A644-A941-FA42-B845-39FDF03B778D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8537" b="8264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41" name="図 40">
              <a:extLst>
                <a:ext uri="{FF2B5EF4-FFF2-40B4-BE49-F238E27FC236}">
                  <a16:creationId xmlns:a16="http://schemas.microsoft.com/office/drawing/2014/main" id="{4EF1DBBD-FE66-4745-BD8D-69793678D6E0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0117" b="8264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42" name="図 41">
              <a:extLst>
                <a:ext uri="{FF2B5EF4-FFF2-40B4-BE49-F238E27FC236}">
                  <a16:creationId xmlns:a16="http://schemas.microsoft.com/office/drawing/2014/main" id="{D230548F-E963-244D-B381-CDE80AC16570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9028" b="8264"/>
            <a:stretch/>
          </p:blipFill>
          <p:spPr>
            <a:xfrm>
              <a:off x="4910400" y="4068000"/>
              <a:ext cx="1728000" cy="2700000"/>
            </a:xfrm>
            <a:prstGeom prst="rect">
              <a:avLst/>
            </a:prstGeom>
          </p:spPr>
        </p:pic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F85F66E7-36E9-D548-8C98-FFC7928F17DB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8752" b="8264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44" name="図 43">
              <a:extLst>
                <a:ext uri="{FF2B5EF4-FFF2-40B4-BE49-F238E27FC236}">
                  <a16:creationId xmlns:a16="http://schemas.microsoft.com/office/drawing/2014/main" id="{D2805C9E-C97F-8F49-B2D8-C5A0886ADF63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467" b="8264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682CC1EE-46EC-4F48-9BBA-AB94E47535B0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9553" b="8509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id="{69737605-72BF-EA4C-B2A0-5DD5212DF99C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0618" b="7386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9B7D77C-B398-C647-9865-BE5796740A09}"/>
              </a:ext>
            </a:extLst>
          </p:cNvPr>
          <p:cNvSpPr txBox="1"/>
          <p:nvPr/>
        </p:nvSpPr>
        <p:spPr>
          <a:xfrm>
            <a:off x="0" y="180000"/>
            <a:ext cx="2152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0669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9BBCF5B-0B78-6348-814F-69C176EFA9E3}"/>
              </a:ext>
            </a:extLst>
          </p:cNvPr>
          <p:cNvSpPr txBox="1"/>
          <p:nvPr/>
        </p:nvSpPr>
        <p:spPr>
          <a:xfrm>
            <a:off x="-1" y="-36000"/>
            <a:ext cx="23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1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BF9100C-72E5-2148-B565-847037528A03}"/>
              </a:ext>
            </a:extLst>
          </p:cNvPr>
          <p:cNvSpPr txBox="1"/>
          <p:nvPr/>
        </p:nvSpPr>
        <p:spPr>
          <a:xfrm>
            <a:off x="0" y="180000"/>
            <a:ext cx="2152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</a:t>
            </a:r>
            <a:endParaRPr kumimoji="1" lang="ja-JP" altLang="en-US" sz="1200">
              <a:latin typeface="Helvetica" pitchFamily="2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6AA262D-F2D1-F244-A0F4-CB44563083DA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580293" cy="6145200"/>
            <a:chOff x="-36000" y="0"/>
            <a:chExt cx="9449883" cy="6768000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AAAB7FD5-CD7F-A947-9B02-1A4B04B10D52}"/>
                </a:ext>
              </a:extLst>
            </p:cNvPr>
            <p:cNvGrpSpPr/>
            <p:nvPr/>
          </p:nvGrpSpPr>
          <p:grpSpPr>
            <a:xfrm>
              <a:off x="-36000" y="0"/>
              <a:ext cx="2380712" cy="238032"/>
              <a:chOff x="-32400" y="0"/>
              <a:chExt cx="2010186" cy="238032"/>
            </a:xfrm>
          </p:grpSpPr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93ED4A19-1692-1D45-B535-BED29B061D25}"/>
                  </a:ext>
                </a:extLst>
              </p:cNvPr>
              <p:cNvSpPr txBox="1"/>
              <p:nvPr/>
            </p:nvSpPr>
            <p:spPr>
              <a:xfrm>
                <a:off x="-32400" y="0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9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51B35F06-A49A-7843-8513-3AC7D38BBE74}"/>
                  </a:ext>
                </a:extLst>
              </p:cNvPr>
              <p:cNvSpPr txBox="1"/>
              <p:nvPr/>
            </p:nvSpPr>
            <p:spPr>
              <a:xfrm>
                <a:off x="119585" y="7200"/>
                <a:ext cx="185820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Natural opium alkaloids (N02AA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27B2960-9ABA-C747-9ED7-982C94689C13}"/>
                </a:ext>
              </a:extLst>
            </p:cNvPr>
            <p:cNvSpPr txBox="1"/>
            <p:nvPr/>
          </p:nvSpPr>
          <p:spPr>
            <a:xfrm>
              <a:off x="14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9–1.2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D70EF3B1-6C9F-2046-97B4-6827B62451EF}"/>
                </a:ext>
              </a:extLst>
            </p:cNvPr>
            <p:cNvGrpSpPr/>
            <p:nvPr/>
          </p:nvGrpSpPr>
          <p:grpSpPr>
            <a:xfrm>
              <a:off x="2322000" y="0"/>
              <a:ext cx="2452689" cy="376532"/>
              <a:chOff x="2392733" y="0"/>
              <a:chExt cx="1785134" cy="376532"/>
            </a:xfrm>
          </p:grpSpPr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16BBA582-D93A-A04F-A693-241BB9555ED4}"/>
                  </a:ext>
                </a:extLst>
              </p:cNvPr>
              <p:cNvSpPr txBox="1"/>
              <p:nvPr/>
            </p:nvSpPr>
            <p:spPr>
              <a:xfrm>
                <a:off x="2392733" y="0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10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45FE6F55-0E1E-0341-B6CC-5BFFAB2C9838}"/>
                  </a:ext>
                </a:extLst>
              </p:cNvPr>
              <p:cNvSpPr txBox="1"/>
              <p:nvPr/>
            </p:nvSpPr>
            <p:spPr>
              <a:xfrm>
                <a:off x="2576146" y="7200"/>
                <a:ext cx="16017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Non-selective monoamine</a:t>
                </a:r>
              </a:p>
              <a:p>
                <a:r>
                  <a:rPr lang="en-US" altLang="ja-JP" sz="900" dirty="0">
                    <a:latin typeface="Helvetica" pitchFamily="2" charset="0"/>
                  </a:rPr>
                  <a:t>reuptake inhibitors (N06AA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C5B1D3D-4310-B74D-97B3-2A496FACD44C}"/>
                </a:ext>
              </a:extLst>
            </p:cNvPr>
            <p:cNvSpPr txBox="1"/>
            <p:nvPr/>
          </p:nvSpPr>
          <p:spPr>
            <a:xfrm>
              <a:off x="2574000" y="324000"/>
              <a:ext cx="14830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2.1, 95% CI 1.02–3.6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CAB221A5-5B9B-184E-A619-AC64B096119C}"/>
                </a:ext>
              </a:extLst>
            </p:cNvPr>
            <p:cNvGrpSpPr/>
            <p:nvPr/>
          </p:nvGrpSpPr>
          <p:grpSpPr>
            <a:xfrm>
              <a:off x="4572000" y="0"/>
              <a:ext cx="2381660" cy="238032"/>
              <a:chOff x="4678732" y="0"/>
              <a:chExt cx="1346665" cy="238032"/>
            </a:xfrm>
          </p:grpSpPr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41A03FF4-0700-9F45-BD24-9DAB8486FD57}"/>
                  </a:ext>
                </a:extLst>
              </p:cNvPr>
              <p:cNvSpPr txBox="1"/>
              <p:nvPr/>
            </p:nvSpPr>
            <p:spPr>
              <a:xfrm>
                <a:off x="4678732" y="0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11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75773F2E-2EFC-6E4D-A431-DA3FBAA4BF8B}"/>
                  </a:ext>
                </a:extLst>
              </p:cNvPr>
              <p:cNvSpPr txBox="1"/>
              <p:nvPr/>
            </p:nvSpPr>
            <p:spPr>
              <a:xfrm>
                <a:off x="4821221" y="7200"/>
                <a:ext cx="120417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Oral bowel cleanser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A2639E5-EE4D-8F4B-8FE2-973292BF10A2}"/>
                </a:ext>
              </a:extLst>
            </p:cNvPr>
            <p:cNvSpPr txBox="1"/>
            <p:nvPr/>
          </p:nvSpPr>
          <p:spPr>
            <a:xfrm>
              <a:off x="4824000" y="180000"/>
              <a:ext cx="14510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2.3, 95% CI 1.4–3.4 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91189D05-343A-C04C-90BF-D2B8AEB8F1DC}"/>
                </a:ext>
              </a:extLst>
            </p:cNvPr>
            <p:cNvGrpSpPr/>
            <p:nvPr/>
          </p:nvGrpSpPr>
          <p:grpSpPr>
            <a:xfrm>
              <a:off x="6912000" y="0"/>
              <a:ext cx="2501883" cy="238032"/>
              <a:chOff x="6976801" y="0"/>
              <a:chExt cx="2273105" cy="238032"/>
            </a:xfrm>
          </p:grpSpPr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8678B170-9735-A347-8E10-00A2E7C7598E}"/>
                  </a:ext>
                </a:extLst>
              </p:cNvPr>
              <p:cNvSpPr txBox="1"/>
              <p:nvPr/>
            </p:nvSpPr>
            <p:spPr>
              <a:xfrm>
                <a:off x="6976801" y="0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12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3521DEC5-4A51-6C4E-A557-D29AA1D83A5F}"/>
                  </a:ext>
                </a:extLst>
              </p:cNvPr>
              <p:cNvSpPr txBox="1"/>
              <p:nvPr/>
            </p:nvSpPr>
            <p:spPr>
              <a:xfrm>
                <a:off x="7205757" y="7200"/>
                <a:ext cx="204414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Other antineoplastic agents (L01XX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323A8795-BD59-594F-B203-448BAE5E8237}"/>
                </a:ext>
              </a:extLst>
            </p:cNvPr>
            <p:cNvSpPr txBox="1"/>
            <p:nvPr/>
          </p:nvSpPr>
          <p:spPr>
            <a:xfrm>
              <a:off x="716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8–1.5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2E7FBB3F-04A2-A640-B6C0-E67566130BC3}"/>
                </a:ext>
              </a:extLst>
            </p:cNvPr>
            <p:cNvGrpSpPr/>
            <p:nvPr/>
          </p:nvGrpSpPr>
          <p:grpSpPr>
            <a:xfrm>
              <a:off x="-36000" y="3492000"/>
              <a:ext cx="1956313" cy="238032"/>
              <a:chOff x="-36000" y="3492000"/>
              <a:chExt cx="1956313" cy="238032"/>
            </a:xfrm>
          </p:grpSpPr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9C4C2FD1-2668-5849-A14E-7173114676E7}"/>
                  </a:ext>
                </a:extLst>
              </p:cNvPr>
              <p:cNvSpPr txBox="1"/>
              <p:nvPr/>
            </p:nvSpPr>
            <p:spPr>
              <a:xfrm>
                <a:off x="-36000" y="3492000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13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6C9D18BD-813C-8449-B916-A0BBA2291A57}"/>
                  </a:ext>
                </a:extLst>
              </p:cNvPr>
              <p:cNvSpPr txBox="1"/>
              <p:nvPr/>
            </p:nvSpPr>
            <p:spPr>
              <a:xfrm>
                <a:off x="216000" y="3499200"/>
                <a:ext cx="170431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Other antipsychotics (N05AX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9DA1E375-F930-9B44-9102-DD6CCF377535}"/>
                </a:ext>
              </a:extLst>
            </p:cNvPr>
            <p:cNvSpPr txBox="1"/>
            <p:nvPr/>
          </p:nvSpPr>
          <p:spPr>
            <a:xfrm>
              <a:off x="216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7–1.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AFD4F8D-2E4B-2342-8954-C9C837E3B85F}"/>
                </a:ext>
              </a:extLst>
            </p:cNvPr>
            <p:cNvSpPr txBox="1"/>
            <p:nvPr/>
          </p:nvSpPr>
          <p:spPr>
            <a:xfrm>
              <a:off x="232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8EC4FD6-EE77-1143-95B5-29DF2BF84A61}"/>
                </a:ext>
              </a:extLst>
            </p:cNvPr>
            <p:cNvSpPr txBox="1"/>
            <p:nvPr/>
          </p:nvSpPr>
          <p:spPr>
            <a:xfrm>
              <a:off x="2572732" y="3499200"/>
              <a:ext cx="16401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henothiazines with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liphatic side-chain (N05A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77A4C899-3964-F946-9937-A2FC4701E633}"/>
                </a:ext>
              </a:extLst>
            </p:cNvPr>
            <p:cNvSpPr txBox="1"/>
            <p:nvPr/>
          </p:nvSpPr>
          <p:spPr>
            <a:xfrm>
              <a:off x="2572732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7–1.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19F34DC9-A2A2-1F4A-A33F-0C1EC549C932}"/>
                </a:ext>
              </a:extLst>
            </p:cNvPr>
            <p:cNvSpPr txBox="1"/>
            <p:nvPr/>
          </p:nvSpPr>
          <p:spPr>
            <a:xfrm>
              <a:off x="457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5E428100-1BD9-A542-AE6C-B114CC198BE3}"/>
                </a:ext>
              </a:extLst>
            </p:cNvPr>
            <p:cNvSpPr txBox="1"/>
            <p:nvPr/>
          </p:nvSpPr>
          <p:spPr>
            <a:xfrm>
              <a:off x="4824001" y="3499200"/>
              <a:ext cx="1990544" cy="4067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(PARP) 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24C42F90-09B3-1F46-9412-17FB94221B37}"/>
                </a:ext>
              </a:extLst>
            </p:cNvPr>
            <p:cNvSpPr txBox="1"/>
            <p:nvPr/>
          </p:nvSpPr>
          <p:spPr>
            <a:xfrm>
              <a:off x="4824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2, 95% CI 0.4–2.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17C53B7A-73E4-4547-892E-61DC9F99ACB6}"/>
                </a:ext>
              </a:extLst>
            </p:cNvPr>
            <p:cNvSpPr txBox="1"/>
            <p:nvPr/>
          </p:nvSpPr>
          <p:spPr>
            <a:xfrm>
              <a:off x="691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40C2EE6F-314C-2D47-8DF9-5173FCA57EDD}"/>
                </a:ext>
              </a:extLst>
            </p:cNvPr>
            <p:cNvSpPr txBox="1"/>
            <p:nvPr/>
          </p:nvSpPr>
          <p:spPr>
            <a:xfrm>
              <a:off x="7164000" y="3499200"/>
              <a:ext cx="17684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EF62E0CE-E98D-1C44-89CC-1838EFC0D2D5}"/>
                </a:ext>
              </a:extLst>
            </p:cNvPr>
            <p:cNvSpPr txBox="1"/>
            <p:nvPr/>
          </p:nvSpPr>
          <p:spPr>
            <a:xfrm>
              <a:off x="7164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9–1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3C6E00AB-A975-2E4F-9658-3A4AA75C4DA0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BBDAE767-7932-8B4E-B2AB-86C50F170AF9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C44CE68F-3F33-B14C-97D0-B7CBA5DF266F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39955085-1DBE-2F48-B481-448861AD16F7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E0CB9C4-851D-3B4F-8715-B1BD13B2BD2C}"/>
                </a:ext>
              </a:extLst>
            </p:cNvPr>
            <p:cNvSpPr txBox="1"/>
            <p:nvPr/>
          </p:nvSpPr>
          <p:spPr>
            <a:xfrm>
              <a:off x="-360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E1DAD6A-5ADD-464A-AA00-E3A5379580C4}"/>
                </a:ext>
              </a:extLst>
            </p:cNvPr>
            <p:cNvSpPr txBox="1"/>
            <p:nvPr/>
          </p:nvSpPr>
          <p:spPr>
            <a:xfrm>
              <a:off x="69732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772D5DCE-E506-7743-AA35-542CACB35A51}"/>
                </a:ext>
              </a:extLst>
            </p:cNvPr>
            <p:cNvSpPr txBox="1"/>
            <p:nvPr/>
          </p:nvSpPr>
          <p:spPr>
            <a:xfrm>
              <a:off x="46368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2DC424E-1DC4-0244-90F7-1F7E47E2FE8F}"/>
                </a:ext>
              </a:extLst>
            </p:cNvPr>
            <p:cNvSpPr txBox="1"/>
            <p:nvPr/>
          </p:nvSpPr>
          <p:spPr>
            <a:xfrm>
              <a:off x="23004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18B4A004-1292-7A48-9008-4E64CB4C598A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l="8262" b="8264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4862EB18-07B1-8246-8EFE-7825FCEF0F4A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9221" b="8264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7998963A-E676-3740-BF16-8AF1D9538BB1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0061" b="8264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F522BA27-CAAA-F847-A755-4E2E593FC95D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9793" b="8264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38" name="図 37">
              <a:extLst>
                <a:ext uri="{FF2B5EF4-FFF2-40B4-BE49-F238E27FC236}">
                  <a16:creationId xmlns:a16="http://schemas.microsoft.com/office/drawing/2014/main" id="{30DAC912-9AF1-D844-AE79-0BC7E69F9135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1013" b="8539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39" name="図 38">
              <a:extLst>
                <a:ext uri="{FF2B5EF4-FFF2-40B4-BE49-F238E27FC236}">
                  <a16:creationId xmlns:a16="http://schemas.microsoft.com/office/drawing/2014/main" id="{30C71E05-588B-5E44-BBB0-40C6A76E5405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162" b="8264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40" name="図 39">
              <a:extLst>
                <a:ext uri="{FF2B5EF4-FFF2-40B4-BE49-F238E27FC236}">
                  <a16:creationId xmlns:a16="http://schemas.microsoft.com/office/drawing/2014/main" id="{033AD50D-2B63-E948-AA1A-6F4C9B1D2DA2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7804" b="8264"/>
            <a:stretch/>
          </p:blipFill>
          <p:spPr>
            <a:xfrm>
              <a:off x="4910400" y="4068000"/>
              <a:ext cx="1728000" cy="2700000"/>
            </a:xfrm>
            <a:prstGeom prst="rect">
              <a:avLst/>
            </a:prstGeom>
          </p:spPr>
        </p:pic>
        <p:pic>
          <p:nvPicPr>
            <p:cNvPr id="41" name="図 40">
              <a:extLst>
                <a:ext uri="{FF2B5EF4-FFF2-40B4-BE49-F238E27FC236}">
                  <a16:creationId xmlns:a16="http://schemas.microsoft.com/office/drawing/2014/main" id="{EE3CEAC7-0889-2C43-8752-E95A703B9D0A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0224" b="8264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16318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DB18BEB-5990-D947-95EE-A46A64FA1F42}"/>
              </a:ext>
            </a:extLst>
          </p:cNvPr>
          <p:cNvSpPr txBox="1"/>
          <p:nvPr/>
        </p:nvSpPr>
        <p:spPr>
          <a:xfrm>
            <a:off x="-1" y="-36000"/>
            <a:ext cx="23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1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A247FAA-0AD2-5042-8607-D9E172E030E8}"/>
              </a:ext>
            </a:extLst>
          </p:cNvPr>
          <p:cNvSpPr txBox="1"/>
          <p:nvPr/>
        </p:nvSpPr>
        <p:spPr>
          <a:xfrm>
            <a:off x="0" y="180000"/>
            <a:ext cx="2152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</a:t>
            </a:r>
            <a:endParaRPr kumimoji="1" lang="ja-JP" altLang="en-US" sz="1200">
              <a:latin typeface="Helvetica" pitchFamily="2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C43DCA34-3009-194A-A60C-32408B92C686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4051980" cy="3060000"/>
            <a:chOff x="-36000" y="0"/>
            <a:chExt cx="4338000" cy="3276000"/>
          </a:xfrm>
        </p:grpSpPr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677E125D-116F-5B40-B6CE-57801FE31AA5}"/>
                </a:ext>
              </a:extLst>
            </p:cNvPr>
            <p:cNvSpPr txBox="1"/>
            <p:nvPr/>
          </p:nvSpPr>
          <p:spPr>
            <a:xfrm>
              <a:off x="-36000" y="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BB260A9B-3986-234D-915F-CCBAE269C4FA}"/>
                </a:ext>
              </a:extLst>
            </p:cNvPr>
            <p:cNvSpPr txBox="1"/>
            <p:nvPr/>
          </p:nvSpPr>
          <p:spPr>
            <a:xfrm>
              <a:off x="216000" y="7200"/>
              <a:ext cx="14863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6306830-0382-AF45-B88D-9EFFE232B3FB}"/>
                </a:ext>
              </a:extLst>
            </p:cNvPr>
            <p:cNvSpPr txBox="1"/>
            <p:nvPr/>
          </p:nvSpPr>
          <p:spPr>
            <a:xfrm>
              <a:off x="216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2, 95% CI 1.1–1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B0E350D6-FB67-2C44-BE09-97AF7A9BEC07}"/>
                </a:ext>
              </a:extLst>
            </p:cNvPr>
            <p:cNvSpPr txBox="1"/>
            <p:nvPr/>
          </p:nvSpPr>
          <p:spPr>
            <a:xfrm>
              <a:off x="2322000" y="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785593EB-A86D-F140-8E27-B9CD070A9C9B}"/>
                </a:ext>
              </a:extLst>
            </p:cNvPr>
            <p:cNvSpPr txBox="1"/>
            <p:nvPr/>
          </p:nvSpPr>
          <p:spPr>
            <a:xfrm>
              <a:off x="2572733" y="7200"/>
              <a:ext cx="140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CD634DC-7C68-2343-B411-9DE9DC06706A}"/>
                </a:ext>
              </a:extLst>
            </p:cNvPr>
            <p:cNvSpPr txBox="1"/>
            <p:nvPr/>
          </p:nvSpPr>
          <p:spPr>
            <a:xfrm>
              <a:off x="2572733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8–1.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2B90A2E8-962A-9E45-9CD7-3367AE2E2575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A9F5E61C-8530-A847-8A88-46E49AB8267B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2B7C2B7F-E604-6C41-AC45-D8E6896CDED3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l="7724" b="8264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66347B9F-673C-7846-8409-3182DF54DDAA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6367" b="8264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90147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0</TotalTime>
  <Words>388</Words>
  <Application>Microsoft Macintosh PowerPoint</Application>
  <PresentationFormat>画面に合わせる (4:3)</PresentationFormat>
  <Paragraphs>8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42</cp:revision>
  <cp:lastPrinted>2021-06-04T10:41:25Z</cp:lastPrinted>
  <dcterms:created xsi:type="dcterms:W3CDTF">2021-03-04T05:02:00Z</dcterms:created>
  <dcterms:modified xsi:type="dcterms:W3CDTF">2021-06-06T06:31:19Z</dcterms:modified>
</cp:coreProperties>
</file>